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78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342" y="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Dietary sodium intake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B$1:$E$1</c:f>
              <c:strCache>
                <c:ptCount val="4"/>
                <c:pt idx="0">
                  <c:v>Quartile 1</c:v>
                </c:pt>
                <c:pt idx="1">
                  <c:v>Quartile 2 </c:v>
                </c:pt>
                <c:pt idx="2">
                  <c:v>Quartile 3 </c:v>
                </c:pt>
                <c:pt idx="3">
                  <c:v>Quartile 4</c:v>
                </c:pt>
              </c:strCache>
            </c:strRef>
          </c:cat>
          <c:val>
            <c:numRef>
              <c:f>Sheet1!$B$2:$E$2</c:f>
              <c:numCache>
                <c:formatCode>General</c:formatCode>
                <c:ptCount val="4"/>
                <c:pt idx="0">
                  <c:v>14.27</c:v>
                </c:pt>
                <c:pt idx="1">
                  <c:v>14.5</c:v>
                </c:pt>
                <c:pt idx="2">
                  <c:v>14.91</c:v>
                </c:pt>
                <c:pt idx="3">
                  <c:v>15.7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6D7-4E3A-AE83-8D197243C7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496947360"/>
        <c:axId val="1496956480"/>
      </c:lineChart>
      <c:catAx>
        <c:axId val="1496947360"/>
        <c:scaling>
          <c:orientation val="minMax"/>
        </c:scaling>
        <c:delete val="0"/>
        <c:axPos val="b"/>
        <c:numFmt formatCode="General" sourceLinked="1"/>
        <c:majorTickMark val="none"/>
        <c:minorTickMark val="in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496956480"/>
        <c:crosses val="autoZero"/>
        <c:auto val="1"/>
        <c:lblAlgn val="ctr"/>
        <c:lblOffset val="100"/>
        <c:noMultiLvlLbl val="0"/>
      </c:catAx>
      <c:valAx>
        <c:axId val="1496956480"/>
        <c:scaling>
          <c:orientation val="minMax"/>
          <c:max val="2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 dirty="0">
                    <a:solidFill>
                      <a:schemeClr val="tx1"/>
                    </a:solidFill>
                  </a:rPr>
                  <a:t>Incident hypertension (%)</a:t>
                </a:r>
                <a:endParaRPr lang="ko-KR" b="1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496947360"/>
        <c:crosses val="autoZero"/>
        <c:crossBetween val="between"/>
      </c:valAx>
      <c:spPr>
        <a:noFill/>
        <a:ln>
          <a:solidFill>
            <a:schemeClr val="bg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Dietary potassium intake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ko-KR"/>
              </a:p>
            </c:txPr>
            <c:dLblPos val="t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B$1:$E$1</c:f>
              <c:strCache>
                <c:ptCount val="4"/>
                <c:pt idx="0">
                  <c:v>Quartile 1</c:v>
                </c:pt>
                <c:pt idx="1">
                  <c:v>Quartile 2 </c:v>
                </c:pt>
                <c:pt idx="2">
                  <c:v>Quartile 3 </c:v>
                </c:pt>
                <c:pt idx="3">
                  <c:v>Quartile 4</c:v>
                </c:pt>
              </c:strCache>
            </c:strRef>
          </c:cat>
          <c:val>
            <c:numRef>
              <c:f>Sheet1!$B$2:$E$2</c:f>
              <c:numCache>
                <c:formatCode>General</c:formatCode>
                <c:ptCount val="4"/>
                <c:pt idx="0">
                  <c:v>15.53</c:v>
                </c:pt>
                <c:pt idx="1">
                  <c:v>14.98</c:v>
                </c:pt>
                <c:pt idx="2">
                  <c:v>14.55</c:v>
                </c:pt>
                <c:pt idx="3">
                  <c:v>14.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E2B-45E3-9F07-955F31A63E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496947360"/>
        <c:axId val="1496956480"/>
      </c:lineChart>
      <c:catAx>
        <c:axId val="1496947360"/>
        <c:scaling>
          <c:orientation val="minMax"/>
        </c:scaling>
        <c:delete val="0"/>
        <c:axPos val="b"/>
        <c:numFmt formatCode="General" sourceLinked="1"/>
        <c:majorTickMark val="none"/>
        <c:minorTickMark val="in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496956480"/>
        <c:crosses val="autoZero"/>
        <c:auto val="1"/>
        <c:lblAlgn val="ctr"/>
        <c:lblOffset val="100"/>
        <c:noMultiLvlLbl val="0"/>
      </c:catAx>
      <c:valAx>
        <c:axId val="1496956480"/>
        <c:scaling>
          <c:orientation val="minMax"/>
          <c:max val="2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 dirty="0">
                    <a:solidFill>
                      <a:schemeClr val="tx1"/>
                    </a:solidFill>
                  </a:rPr>
                  <a:t>Incident hypertension (%)</a:t>
                </a:r>
                <a:endParaRPr lang="ko-KR" b="1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496947360"/>
        <c:crosses val="autoZero"/>
        <c:crossBetween val="between"/>
      </c:valAx>
      <c:spPr>
        <a:noFill/>
        <a:ln>
          <a:solidFill>
            <a:schemeClr val="bg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7AACCF8-8B91-4175-9C75-11A3264F275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95452FBA-7B50-484C-B8A4-D27E5C73B18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1F7A750-C731-4232-87AE-6823B6251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1E125-7934-45DD-941A-1CD466823273}" type="datetimeFigureOut">
              <a:rPr lang="ko-KR" altLang="en-US" smtClean="0"/>
              <a:t>2024-06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FE06CFC-5B09-4B4B-9BA3-5EF3AC951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105C099-47A1-4FA8-9FF5-5692A94950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0EBED-4B3B-4DD1-9FDF-ADE5BB1F3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4153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B04827E-83AA-4DC3-8AF6-7F4E6E1531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37F6E37-0ECF-433A-8070-61C990EDCA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D68A18A-F95B-462B-9330-3713F0F3FE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1E125-7934-45DD-941A-1CD466823273}" type="datetimeFigureOut">
              <a:rPr lang="ko-KR" altLang="en-US" smtClean="0"/>
              <a:t>2024-06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C64DEB9-42E6-4919-B325-AD1FDFAB51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7BD8109-88D7-46D2-A924-993B14BA2E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0EBED-4B3B-4DD1-9FDF-ADE5BB1F3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2913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79B522A7-18AA-4101-A454-36E66DADF9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30DD95D7-A945-473C-90DD-4B7965DBFF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7EE01A2-30B0-4A8D-8725-D8B07A98D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1E125-7934-45DD-941A-1CD466823273}" type="datetimeFigureOut">
              <a:rPr lang="ko-KR" altLang="en-US" smtClean="0"/>
              <a:t>2024-06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013F458-C78D-4EC6-8449-6BC691307A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0FE6FDD-245A-49CB-833C-3AF6BD0609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0EBED-4B3B-4DD1-9FDF-ADE5BB1F3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85971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084F166-C92A-4F37-938D-5C749821F0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F44B916-1724-49DD-A186-D5B9BA9BD1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D4D6000-3B94-4E6D-89D8-9E04E298DB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1E125-7934-45DD-941A-1CD466823273}" type="datetimeFigureOut">
              <a:rPr lang="ko-KR" altLang="en-US" smtClean="0"/>
              <a:t>2024-06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43F7F0B-4D4B-4D48-83A9-F38F8C1E18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7A7D0EF-DBC5-43EC-BEDF-E5B7CAB47A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0EBED-4B3B-4DD1-9FDF-ADE5BB1F3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60501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C66AEDF-1C6C-435F-A59D-201B67D045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5B6EFC0-28A6-479B-AACD-9BB2ABD9C6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C776E7D-A90C-4AA0-8A87-270E47748B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1E125-7934-45DD-941A-1CD466823273}" type="datetimeFigureOut">
              <a:rPr lang="ko-KR" altLang="en-US" smtClean="0"/>
              <a:t>2024-06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B80535E-FE6C-450C-BD91-32F437A14B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674DF23-49D8-4D56-A361-3CE07E3767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0EBED-4B3B-4DD1-9FDF-ADE5BB1F3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29813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4417E58-13F8-4E1C-9C21-2EE14690CB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ABBAF30-8144-43EF-846C-CC5063821C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0B696359-7DB0-448A-9CA1-401E361827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C5E02D9-2D13-458D-B5AF-0EF62AF396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1E125-7934-45DD-941A-1CD466823273}" type="datetimeFigureOut">
              <a:rPr lang="ko-KR" altLang="en-US" smtClean="0"/>
              <a:t>2024-06-0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013EBAA-738E-4406-992A-8B89DB15BF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334A9DA-FD09-405A-ABC5-576F8E345C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0EBED-4B3B-4DD1-9FDF-ADE5BB1F3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0595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96A9132-35A3-4DF4-890E-C2C6A807AE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0DF511D-C3E1-4FF8-A9DA-0A986BDDDA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FCD9F79-408C-494C-A241-C414255B57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30A4FE18-0E42-4878-AD8C-35A9CBA4A8E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1F0B3CA8-AA9B-4007-BF7D-5A4C2C9D50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8F214E98-E935-4C25-9709-CDD23BAB27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1E125-7934-45DD-941A-1CD466823273}" type="datetimeFigureOut">
              <a:rPr lang="ko-KR" altLang="en-US" smtClean="0"/>
              <a:t>2024-06-05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9C6BAD60-F18E-4FCE-AF83-77A43719A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F14348A-CA71-4898-91DF-FB950D3B71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0EBED-4B3B-4DD1-9FDF-ADE5BB1F3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8204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F542333-9912-4B4C-B90A-4C7881948D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8EFBB50D-B77B-42E5-9259-71A7E8975A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1E125-7934-45DD-941A-1CD466823273}" type="datetimeFigureOut">
              <a:rPr lang="ko-KR" altLang="en-US" smtClean="0"/>
              <a:t>2024-06-05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B8998769-9552-46FF-809E-F61F779D07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8616CB86-8D47-4FE0-9705-0F5D337C56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0EBED-4B3B-4DD1-9FDF-ADE5BB1F3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67154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74962F42-8D5C-47E6-BA8A-46D01DE8B3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1E125-7934-45DD-941A-1CD466823273}" type="datetimeFigureOut">
              <a:rPr lang="ko-KR" altLang="en-US" smtClean="0"/>
              <a:t>2024-06-05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CDA2BC10-1144-490E-BCC3-06C3AFD801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799A9465-0D2E-4AFD-B84E-FF5F5D5A2E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0EBED-4B3B-4DD1-9FDF-ADE5BB1F3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8149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879333C-2E22-4783-AD02-A26AF0750F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F43D34E-D9C0-472C-9883-1D25AA723A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D37E18E-FBCB-448C-894B-F1C49010F5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A8389E6-722D-4BF2-8C0B-EBCBD58E4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1E125-7934-45DD-941A-1CD466823273}" type="datetimeFigureOut">
              <a:rPr lang="ko-KR" altLang="en-US" smtClean="0"/>
              <a:t>2024-06-0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72A0D48-1C29-4B9E-9018-5F0A55CB63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DCCE89B-4E46-44FD-BF4E-D7D0D7A198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0EBED-4B3B-4DD1-9FDF-ADE5BB1F3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8003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15DC66D-28C5-4223-A8B1-13629B003A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8CB457E5-A0B0-4E78-ADE4-D5F43CADD9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763AE51-D796-4CE4-88A7-257028A15E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29AA56F-1AD6-4359-90F7-D58D71A0F3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1E125-7934-45DD-941A-1CD466823273}" type="datetimeFigureOut">
              <a:rPr lang="ko-KR" altLang="en-US" smtClean="0"/>
              <a:t>2024-06-0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F7B86FE-60B5-433A-A8F7-56CBA800F7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DBEC243-A0DE-4F66-982D-D7320735C7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C0EBED-4B3B-4DD1-9FDF-ADE5BB1F3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3302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E31C23F4-24FC-4F82-B76D-85EFC1B5D8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5306A02-CD5C-4BB2-9981-A2B08A8D53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7D1103A-CAEF-4545-8425-FE781749C05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91E125-7934-45DD-941A-1CD466823273}" type="datetimeFigureOut">
              <a:rPr lang="ko-KR" altLang="en-US" smtClean="0"/>
              <a:t>2024-06-0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0ADCB64-C026-4AA9-A474-DF7301D6DF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EF39B2A-5116-4647-B559-B720371F6C7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C0EBED-4B3B-4DD1-9FDF-ADE5BB1F3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7487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>
            <a:extLst>
              <a:ext uri="{FF2B5EF4-FFF2-40B4-BE49-F238E27FC236}">
                <a16:creationId xmlns:a16="http://schemas.microsoft.com/office/drawing/2014/main" id="{00000000-0008-0000-0700-000002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0482"/>
          <a:stretch/>
        </p:blipFill>
        <p:spPr>
          <a:xfrm>
            <a:off x="1261120" y="1479175"/>
            <a:ext cx="7542437" cy="336862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9D9940F-5E7B-6BAA-09F8-5B840B24D34F}"/>
              </a:ext>
            </a:extLst>
          </p:cNvPr>
          <p:cNvSpPr txBox="1"/>
          <p:nvPr/>
        </p:nvSpPr>
        <p:spPr>
          <a:xfrm>
            <a:off x="7734468" y="3748974"/>
            <a:ext cx="22611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&lt;0.001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76CF904-3141-729B-0B2F-A4C4D6FC3AF1}"/>
              </a:ext>
            </a:extLst>
          </p:cNvPr>
          <p:cNvSpPr txBox="1"/>
          <p:nvPr/>
        </p:nvSpPr>
        <p:spPr>
          <a:xfrm>
            <a:off x="125506" y="4961422"/>
            <a:ext cx="9225598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Number At Risk (n)</a:t>
            </a:r>
          </a:p>
          <a:p>
            <a:endParaRPr lang="en-US" altLang="ko-KR" sz="11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PRS</a:t>
            </a:r>
            <a:r>
              <a:rPr lang="en-US" altLang="ko-KR" sz="11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SBP</a:t>
            </a:r>
            <a:r>
              <a:rPr lang="ko-KR" altLang="en-US" sz="11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top 10%                      4,135                              3,819                                    997                                   84                                       0</a:t>
            </a:r>
          </a:p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PRS</a:t>
            </a:r>
            <a:r>
              <a:rPr lang="en-US" altLang="ko-KR" sz="11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SBP</a:t>
            </a:r>
            <a:r>
              <a:rPr lang="ko-KR" altLang="en-US" sz="11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middle                        33,080                            30,621                                  8,046                                761                                     0</a:t>
            </a:r>
          </a:p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PRS</a:t>
            </a:r>
            <a:r>
              <a:rPr lang="en-US" altLang="ko-KR" sz="11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SBP</a:t>
            </a:r>
            <a:r>
              <a:rPr lang="ko-KR" altLang="en-US" sz="11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bottom</a:t>
            </a:r>
            <a:r>
              <a: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10%               4,136                              3,845                                    1,021                                96                                       0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4ECC6E8-538A-7C8F-0B1E-2D5530FBD79C}"/>
              </a:ext>
            </a:extLst>
          </p:cNvPr>
          <p:cNvSpPr txBox="1"/>
          <p:nvPr/>
        </p:nvSpPr>
        <p:spPr>
          <a:xfrm>
            <a:off x="4598895" y="4622868"/>
            <a:ext cx="209774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llow-up,</a:t>
            </a:r>
            <a:r>
              <a:rPr lang="ko-KR" altLang="en-US" sz="16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ko-KR" sz="16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year</a:t>
            </a:r>
            <a:endParaRPr lang="ko-KR" altLang="en-US" sz="1600" b="1" dirty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0CD81E6-AB8E-A759-4431-26CC555DA097}"/>
              </a:ext>
            </a:extLst>
          </p:cNvPr>
          <p:cNvSpPr txBox="1"/>
          <p:nvPr/>
        </p:nvSpPr>
        <p:spPr>
          <a:xfrm>
            <a:off x="376354" y="440011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그룹 20">
            <a:extLst>
              <a:ext uri="{FF2B5EF4-FFF2-40B4-BE49-F238E27FC236}">
                <a16:creationId xmlns:a16="http://schemas.microsoft.com/office/drawing/2014/main" id="{5C8A843B-7817-CD7B-193F-2CEBB8D74347}"/>
              </a:ext>
            </a:extLst>
          </p:cNvPr>
          <p:cNvGrpSpPr/>
          <p:nvPr/>
        </p:nvGrpSpPr>
        <p:grpSpPr>
          <a:xfrm>
            <a:off x="8591675" y="2106535"/>
            <a:ext cx="1654257" cy="771040"/>
            <a:chOff x="8591675" y="2106535"/>
            <a:chExt cx="1654257" cy="771040"/>
          </a:xfrm>
        </p:grpSpPr>
        <p:cxnSp>
          <p:nvCxnSpPr>
            <p:cNvPr id="7" name="직선 연결선 6">
              <a:extLst>
                <a:ext uri="{FF2B5EF4-FFF2-40B4-BE49-F238E27FC236}">
                  <a16:creationId xmlns:a16="http://schemas.microsoft.com/office/drawing/2014/main" id="{B1437425-1C46-BF5C-1390-6FE517AFFAD5}"/>
                </a:ext>
              </a:extLst>
            </p:cNvPr>
            <p:cNvCxnSpPr>
              <a:cxnSpLocks/>
            </p:cNvCxnSpPr>
            <p:nvPr/>
          </p:nvCxnSpPr>
          <p:spPr>
            <a:xfrm rot="10800000">
              <a:off x="8592542" y="2744558"/>
              <a:ext cx="268941" cy="0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직선 연결선 10">
              <a:extLst>
                <a:ext uri="{FF2B5EF4-FFF2-40B4-BE49-F238E27FC236}">
                  <a16:creationId xmlns:a16="http://schemas.microsoft.com/office/drawing/2014/main" id="{7B4A2E56-C52C-C58C-290B-B398B85A1085}"/>
                </a:ext>
              </a:extLst>
            </p:cNvPr>
            <p:cNvCxnSpPr>
              <a:cxnSpLocks/>
            </p:cNvCxnSpPr>
            <p:nvPr/>
          </p:nvCxnSpPr>
          <p:spPr>
            <a:xfrm rot="10800000">
              <a:off x="8591675" y="2490642"/>
              <a:ext cx="268941" cy="0"/>
            </a:xfrm>
            <a:prstGeom prst="line">
              <a:avLst/>
            </a:prstGeom>
            <a:ln w="19050">
              <a:solidFill>
                <a:srgbClr val="FF7C8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직선 연결선 12">
              <a:extLst>
                <a:ext uri="{FF2B5EF4-FFF2-40B4-BE49-F238E27FC236}">
                  <a16:creationId xmlns:a16="http://schemas.microsoft.com/office/drawing/2014/main" id="{144BF1D9-AC91-3025-83CB-B58E01F2219E}"/>
                </a:ext>
              </a:extLst>
            </p:cNvPr>
            <p:cNvCxnSpPr>
              <a:cxnSpLocks/>
            </p:cNvCxnSpPr>
            <p:nvPr/>
          </p:nvCxnSpPr>
          <p:spPr>
            <a:xfrm rot="10800000">
              <a:off x="8592541" y="2230667"/>
              <a:ext cx="268941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9A7B7E2-A62B-D7DF-D921-F234C5455581}"/>
                </a:ext>
              </a:extLst>
            </p:cNvPr>
            <p:cNvSpPr txBox="1"/>
            <p:nvPr/>
          </p:nvSpPr>
          <p:spPr>
            <a:xfrm>
              <a:off x="8860616" y="2623659"/>
              <a:ext cx="13853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Arial" panose="020B0604020202020204" pitchFamily="34" charset="0"/>
                  <a:cs typeface="Arial" panose="020B0604020202020204" pitchFamily="34" charset="0"/>
                </a:rPr>
                <a:t>PRS</a:t>
              </a:r>
              <a:r>
                <a:rPr lang="en-US" altLang="ko-KR" sz="105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SBP</a:t>
              </a:r>
              <a:r>
                <a:rPr lang="ko-KR" altLang="en-US" sz="105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50" dirty="0">
                  <a:latin typeface="Arial" panose="020B0604020202020204" pitchFamily="34" charset="0"/>
                  <a:cs typeface="Arial" panose="020B0604020202020204" pitchFamily="34" charset="0"/>
                </a:rPr>
                <a:t>bottom 10%</a:t>
              </a:r>
              <a:endParaRPr lang="ko-KR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1FABCC8-0A35-89C3-E219-09C5CB6C2E7D}"/>
                </a:ext>
              </a:extLst>
            </p:cNvPr>
            <p:cNvSpPr txBox="1"/>
            <p:nvPr/>
          </p:nvSpPr>
          <p:spPr>
            <a:xfrm>
              <a:off x="8860616" y="2357625"/>
              <a:ext cx="10647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Arial" panose="020B0604020202020204" pitchFamily="34" charset="0"/>
                  <a:cs typeface="Arial" panose="020B0604020202020204" pitchFamily="34" charset="0"/>
                </a:rPr>
                <a:t>PRS</a:t>
              </a:r>
              <a:r>
                <a:rPr lang="en-US" altLang="ko-KR" sz="105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SBP</a:t>
              </a:r>
              <a:r>
                <a:rPr lang="ko-KR" altLang="en-US" sz="105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50" dirty="0">
                  <a:latin typeface="Arial" panose="020B0604020202020204" pitchFamily="34" charset="0"/>
                  <a:cs typeface="Arial" panose="020B0604020202020204" pitchFamily="34" charset="0"/>
                </a:rPr>
                <a:t>middle</a:t>
              </a:r>
              <a:endParaRPr lang="ko-KR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15B2E39-ED94-BCF8-31E5-C227557F66EF}"/>
                </a:ext>
              </a:extLst>
            </p:cNvPr>
            <p:cNvSpPr txBox="1"/>
            <p:nvPr/>
          </p:nvSpPr>
          <p:spPr>
            <a:xfrm>
              <a:off x="8860616" y="2106535"/>
              <a:ext cx="138531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dirty="0">
                  <a:latin typeface="Arial" panose="020B0604020202020204" pitchFamily="34" charset="0"/>
                  <a:cs typeface="Arial" panose="020B0604020202020204" pitchFamily="34" charset="0"/>
                </a:rPr>
                <a:t>PRS</a:t>
              </a:r>
              <a:r>
                <a:rPr lang="en-US" altLang="ko-KR" sz="105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SBP</a:t>
              </a:r>
              <a:r>
                <a:rPr lang="ko-KR" altLang="en-US" sz="105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050" dirty="0">
                  <a:latin typeface="Arial" panose="020B0604020202020204" pitchFamily="34" charset="0"/>
                  <a:cs typeface="Arial" panose="020B0604020202020204" pitchFamily="34" charset="0"/>
                </a:rPr>
                <a:t>top 10%</a:t>
              </a:r>
              <a:endParaRPr lang="ko-KR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919870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DB2FDCD-C92C-9AF7-C058-A7439AF44DF0}"/>
              </a:ext>
            </a:extLst>
          </p:cNvPr>
          <p:cNvSpPr txBox="1"/>
          <p:nvPr/>
        </p:nvSpPr>
        <p:spPr>
          <a:xfrm>
            <a:off x="394283" y="453006"/>
            <a:ext cx="19896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차트 2">
            <a:extLst>
              <a:ext uri="{FF2B5EF4-FFF2-40B4-BE49-F238E27FC236}">
                <a16:creationId xmlns:a16="http://schemas.microsoft.com/office/drawing/2014/main" id="{BE226FF9-C1A7-7B13-B7A8-7F4C0AF877E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367451"/>
              </p:ext>
            </p:extLst>
          </p:nvPr>
        </p:nvGraphicFramePr>
        <p:xfrm>
          <a:off x="0" y="1448671"/>
          <a:ext cx="5824889" cy="38525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7" name="직선 연결선 6">
            <a:extLst>
              <a:ext uri="{FF2B5EF4-FFF2-40B4-BE49-F238E27FC236}">
                <a16:creationId xmlns:a16="http://schemas.microsoft.com/office/drawing/2014/main" id="{8153B103-EE72-C8DF-7E39-BD35657CACC0}"/>
              </a:ext>
            </a:extLst>
          </p:cNvPr>
          <p:cNvCxnSpPr/>
          <p:nvPr/>
        </p:nvCxnSpPr>
        <p:spPr>
          <a:xfrm>
            <a:off x="4429191" y="3258892"/>
            <a:ext cx="3524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0243905C-17DF-443F-3330-A7CF39FCE938}"/>
              </a:ext>
            </a:extLst>
          </p:cNvPr>
          <p:cNvSpPr txBox="1"/>
          <p:nvPr/>
        </p:nvSpPr>
        <p:spPr>
          <a:xfrm>
            <a:off x="4749996" y="3131934"/>
            <a:ext cx="117214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Sodium intake</a:t>
            </a:r>
            <a:endParaRPr lang="ko-KR" altLang="en-US" sz="105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표 4">
            <a:extLst>
              <a:ext uri="{FF2B5EF4-FFF2-40B4-BE49-F238E27FC236}">
                <a16:creationId xmlns:a16="http://schemas.microsoft.com/office/drawing/2014/main" id="{8797D6C8-F0AF-EC84-39AA-544454CEC48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36225552"/>
              </p:ext>
            </p:extLst>
          </p:nvPr>
        </p:nvGraphicFramePr>
        <p:xfrm>
          <a:off x="805804" y="5287868"/>
          <a:ext cx="4958125" cy="426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43906">
                  <a:extLst>
                    <a:ext uri="{9D8B030D-6E8A-4147-A177-3AD203B41FA5}">
                      <a16:colId xmlns:a16="http://schemas.microsoft.com/office/drawing/2014/main" val="2885098744"/>
                    </a:ext>
                  </a:extLst>
                </a:gridCol>
                <a:gridCol w="1272988">
                  <a:extLst>
                    <a:ext uri="{9D8B030D-6E8A-4147-A177-3AD203B41FA5}">
                      <a16:colId xmlns:a16="http://schemas.microsoft.com/office/drawing/2014/main" val="3523857250"/>
                    </a:ext>
                  </a:extLst>
                </a:gridCol>
                <a:gridCol w="1227487">
                  <a:extLst>
                    <a:ext uri="{9D8B030D-6E8A-4147-A177-3AD203B41FA5}">
                      <a16:colId xmlns:a16="http://schemas.microsoft.com/office/drawing/2014/main" val="1023352642"/>
                    </a:ext>
                  </a:extLst>
                </a:gridCol>
                <a:gridCol w="1213744">
                  <a:extLst>
                    <a:ext uri="{9D8B030D-6E8A-4147-A177-3AD203B41FA5}">
                      <a16:colId xmlns:a16="http://schemas.microsoft.com/office/drawing/2014/main" val="350162370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 ± 0.3</a:t>
                      </a:r>
                    </a:p>
                    <a:p>
                      <a:pPr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0.0, 1.5]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.9 ± 0.2</a:t>
                      </a:r>
                    </a:p>
                    <a:p>
                      <a:pPr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[1.5, 2.3]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b="1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2.7 ± 0.2</a:t>
                      </a:r>
                    </a:p>
                    <a:p>
                      <a:pPr latinLnBrk="1"/>
                      <a:r>
                        <a:rPr lang="en-US" altLang="ko-KR" sz="1100" b="1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[2.3, 3.1]</a:t>
                      </a:r>
                      <a:endParaRPr lang="ko-KR" altLang="en-US" sz="1100" b="1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b="1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4.3 ± 1.4</a:t>
                      </a:r>
                    </a:p>
                    <a:p>
                      <a:pPr latinLnBrk="1"/>
                      <a:r>
                        <a:rPr lang="en-US" altLang="ko-KR" sz="1100" b="1" kern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[3.1, 16.1]</a:t>
                      </a:r>
                      <a:endParaRPr lang="ko-KR" altLang="en-US" sz="1100" b="1" kern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4686352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AEF19299-C550-A159-6AE4-A052992AC3F8}"/>
              </a:ext>
            </a:extLst>
          </p:cNvPr>
          <p:cNvSpPr txBox="1"/>
          <p:nvPr/>
        </p:nvSpPr>
        <p:spPr>
          <a:xfrm>
            <a:off x="328242" y="6258799"/>
            <a:ext cx="51684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odium and potassium intake, mean ± standard deviation [minimum, maximum]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D0C3228-A46D-4774-8A77-E0A7D737BE61}"/>
              </a:ext>
            </a:extLst>
          </p:cNvPr>
          <p:cNvSpPr txBox="1"/>
          <p:nvPr/>
        </p:nvSpPr>
        <p:spPr>
          <a:xfrm>
            <a:off x="-3583" y="118086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71C047C-5A86-4A24-9F37-A9872117E6DB}"/>
              </a:ext>
            </a:extLst>
          </p:cNvPr>
          <p:cNvSpPr txBox="1"/>
          <p:nvPr/>
        </p:nvSpPr>
        <p:spPr>
          <a:xfrm>
            <a:off x="2383930" y="5714588"/>
            <a:ext cx="16662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odium intake (g/day)</a:t>
            </a:r>
            <a:endParaRPr lang="ko-KR" alt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B3EDC2F-BBA4-447B-A1E5-9BCEAE81D0D5}"/>
              </a:ext>
            </a:extLst>
          </p:cNvPr>
          <p:cNvSpPr txBox="1"/>
          <p:nvPr/>
        </p:nvSpPr>
        <p:spPr>
          <a:xfrm>
            <a:off x="6198765" y="118086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차트 11">
            <a:extLst>
              <a:ext uri="{FF2B5EF4-FFF2-40B4-BE49-F238E27FC236}">
                <a16:creationId xmlns:a16="http://schemas.microsoft.com/office/drawing/2014/main" id="{F338CFDD-1E5B-430B-9A9A-B2854758B31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8202429"/>
              </p:ext>
            </p:extLst>
          </p:nvPr>
        </p:nvGraphicFramePr>
        <p:xfrm>
          <a:off x="6170327" y="1451944"/>
          <a:ext cx="5824889" cy="38525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13" name="직선 연결선 12">
            <a:extLst>
              <a:ext uri="{FF2B5EF4-FFF2-40B4-BE49-F238E27FC236}">
                <a16:creationId xmlns:a16="http://schemas.microsoft.com/office/drawing/2014/main" id="{012FFAD8-BCDA-4608-813F-E5EAEE630EDE}"/>
              </a:ext>
            </a:extLst>
          </p:cNvPr>
          <p:cNvCxnSpPr/>
          <p:nvPr/>
        </p:nvCxnSpPr>
        <p:spPr>
          <a:xfrm>
            <a:off x="10372791" y="3290564"/>
            <a:ext cx="3524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414FD27A-3D36-4F1C-9383-B0D34F61682F}"/>
              </a:ext>
            </a:extLst>
          </p:cNvPr>
          <p:cNvSpPr txBox="1"/>
          <p:nvPr/>
        </p:nvSpPr>
        <p:spPr>
          <a:xfrm>
            <a:off x="10778271" y="3163606"/>
            <a:ext cx="208146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Potassium intake</a:t>
            </a:r>
            <a:endParaRPr lang="ko-KR" altLang="en-US" sz="105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" name="표 14">
            <a:extLst>
              <a:ext uri="{FF2B5EF4-FFF2-40B4-BE49-F238E27FC236}">
                <a16:creationId xmlns:a16="http://schemas.microsoft.com/office/drawing/2014/main" id="{F5C95515-11D0-4B88-B112-6D9E0F0C92D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8424692"/>
              </p:ext>
            </p:extLst>
          </p:nvPr>
        </p:nvGraphicFramePr>
        <p:xfrm>
          <a:off x="7002308" y="5301182"/>
          <a:ext cx="4792994" cy="426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37059">
                  <a:extLst>
                    <a:ext uri="{9D8B030D-6E8A-4147-A177-3AD203B41FA5}">
                      <a16:colId xmlns:a16="http://schemas.microsoft.com/office/drawing/2014/main" val="2885098744"/>
                    </a:ext>
                  </a:extLst>
                </a:gridCol>
                <a:gridCol w="1209295">
                  <a:extLst>
                    <a:ext uri="{9D8B030D-6E8A-4147-A177-3AD203B41FA5}">
                      <a16:colId xmlns:a16="http://schemas.microsoft.com/office/drawing/2014/main" val="3523857250"/>
                    </a:ext>
                  </a:extLst>
                </a:gridCol>
                <a:gridCol w="1327717">
                  <a:extLst>
                    <a:ext uri="{9D8B030D-6E8A-4147-A177-3AD203B41FA5}">
                      <a16:colId xmlns:a16="http://schemas.microsoft.com/office/drawing/2014/main" val="1023352642"/>
                    </a:ext>
                  </a:extLst>
                </a:gridCol>
                <a:gridCol w="1018923">
                  <a:extLst>
                    <a:ext uri="{9D8B030D-6E8A-4147-A177-3AD203B41FA5}">
                      <a16:colId xmlns:a16="http://schemas.microsoft.com/office/drawing/2014/main" val="350162370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.2 ± 0.2</a:t>
                      </a:r>
                    </a:p>
                    <a:p>
                      <a:pPr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[0.1, 1.6]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.8 ± 0.1</a:t>
                      </a:r>
                    </a:p>
                    <a:p>
                      <a:pPr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[1.6, 2.1]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2.4 ± 0.2</a:t>
                      </a:r>
                    </a:p>
                    <a:p>
                      <a:pPr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[2.1, 2.7]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3.6 ± 1.1</a:t>
                      </a:r>
                    </a:p>
                    <a:p>
                      <a:pPr latinLnBrk="1"/>
                      <a:r>
                        <a:rPr lang="en-US" altLang="ko-KR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[2.7, 19.1]</a:t>
                      </a:r>
                      <a:endParaRPr lang="ko-KR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4686352"/>
                  </a:ext>
                </a:extLst>
              </a:tr>
            </a:tbl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4A6D50B2-CC86-4059-9E87-8E07CD166A60}"/>
              </a:ext>
            </a:extLst>
          </p:cNvPr>
          <p:cNvSpPr txBox="1"/>
          <p:nvPr/>
        </p:nvSpPr>
        <p:spPr>
          <a:xfrm>
            <a:off x="8402320" y="5714588"/>
            <a:ext cx="17864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Potassium intake (g/day) </a:t>
            </a:r>
          </a:p>
        </p:txBody>
      </p:sp>
    </p:spTree>
    <p:extLst>
      <p:ext uri="{BB962C8B-B14F-4D97-AF65-F5344CB8AC3E}">
        <p14:creationId xmlns:p14="http://schemas.microsoft.com/office/powerpoint/2010/main" val="14837865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44</TotalTime>
  <Words>175</Words>
  <Application>Microsoft Office PowerPoint</Application>
  <PresentationFormat>와이드스크린</PresentationFormat>
  <Paragraphs>37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Arial Unicode MS</vt:lpstr>
      <vt:lpstr>맑은 고딕</vt:lpstr>
      <vt:lpstr>Arial</vt:lpstr>
      <vt:lpstr>Calibri</vt:lpstr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배 은진</dc:creator>
  <cp:lastModifiedBy>Jeonghwan Lee</cp:lastModifiedBy>
  <cp:revision>152</cp:revision>
  <dcterms:created xsi:type="dcterms:W3CDTF">2020-10-13T01:37:27Z</dcterms:created>
  <dcterms:modified xsi:type="dcterms:W3CDTF">2024-06-05T01:11:23Z</dcterms:modified>
</cp:coreProperties>
</file>